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532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3B8DA70-77B6-4F5D-3C3F-40B3D18D61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1D02D1D-53AE-B674-3C21-26215FBF376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83B0623-D5C2-7D0F-EF42-B0AC6A4314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6144D-93FC-465C-BD67-DC6F4031BE5F}" type="datetimeFigureOut">
              <a:rPr lang="zh-CN" altLang="en-US" smtClean="0"/>
              <a:t>2025/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1F9416-3068-0F0C-E4B2-786A58FFA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A49BE21-F15D-0251-0489-57CD76BC9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5D10B-722A-4F78-B4DD-B6BC0898A0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0222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0F97448-2542-6BE1-A70D-E9237FD76E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3BC832C-3953-5A5D-E171-C719AC04E6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F061017-9624-A512-D25D-E445BAC6D9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6144D-93FC-465C-BD67-DC6F4031BE5F}" type="datetimeFigureOut">
              <a:rPr lang="zh-CN" altLang="en-US" smtClean="0"/>
              <a:t>2025/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3167654-1244-8E7F-0B5A-73AB755ADF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9ED7ABE-6F33-DAE5-AACA-00987F8B9D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5D10B-722A-4F78-B4DD-B6BC0898A0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5186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2FA0805-DDC9-2CF0-028B-050BF25BFC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5DF2339-D740-8DF3-6A9C-31434F78A7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7BC3BAE-73EA-872D-E0A7-5AC5C69DE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6144D-93FC-465C-BD67-DC6F4031BE5F}" type="datetimeFigureOut">
              <a:rPr lang="zh-CN" altLang="en-US" smtClean="0"/>
              <a:t>2025/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99B982C-FBE2-D0FE-9707-851D045FC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F584EC7-DCAC-338A-E16C-1611102503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5D10B-722A-4F78-B4DD-B6BC0898A0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90076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D6E73C-83C2-34F2-BF53-DE6AA042C9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7F0E650-EE15-DD71-9E0F-15F8F2A0FA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0741762-7FC2-B2D4-0BD6-A16050C5F3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6144D-93FC-465C-BD67-DC6F4031BE5F}" type="datetimeFigureOut">
              <a:rPr lang="zh-CN" altLang="en-US" smtClean="0"/>
              <a:t>2025/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A8E616-E68A-FA0B-2521-76D9CBA8D8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504A831-0AA5-739D-B511-637B3CC07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5D10B-722A-4F78-B4DD-B6BC0898A0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5924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297F15-814B-445A-F306-7EB4504BE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CE4E67F-2A4D-2253-7E3D-B0BE811681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78458C1-21EB-E7F6-82FF-39F14EAF63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6144D-93FC-465C-BD67-DC6F4031BE5F}" type="datetimeFigureOut">
              <a:rPr lang="zh-CN" altLang="en-US" smtClean="0"/>
              <a:t>2025/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47A5BE9-D019-15F5-A0C2-5DD390B33F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6CFEFA-F472-BF47-6500-C4FA60063F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5D10B-722A-4F78-B4DD-B6BC0898A0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35159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890FE6-3524-6BF6-371A-B524C9ED37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578B882-884D-755A-DF40-015BF0D850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CA86123-13E5-A392-9EBB-B5D0E544A0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7E3F7F2-BAE9-5B7B-088A-55FF2820EE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6144D-93FC-465C-BD67-DC6F4031BE5F}" type="datetimeFigureOut">
              <a:rPr lang="zh-CN" altLang="en-US" smtClean="0"/>
              <a:t>2025/1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C442DF6-CD27-FBF3-A4C9-5FF210F4C2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CE0C5B9-549A-FC1F-EF4A-BCAE680DCF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5D10B-722A-4F78-B4DD-B6BC0898A0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616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FF07DE-4E24-90E1-DB33-3645C83601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A6CF9E7-C785-947D-97B1-9EA50488A2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0EC1FAA-485F-5880-0160-C2E6260A4A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0DD5A0C-CBB8-4194-235F-74C6D5F111B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F41B1AC-AC27-ABE8-1CAB-4315E36390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1FBA8BC-9FCB-CC13-FA31-9E0ADB14EE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6144D-93FC-465C-BD67-DC6F4031BE5F}" type="datetimeFigureOut">
              <a:rPr lang="zh-CN" altLang="en-US" smtClean="0"/>
              <a:t>2025/1/1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D0AA555-19F6-F945-FD02-30BE2E34F4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51993DB-2F48-FFAA-9278-C0E5699B66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5D10B-722A-4F78-B4DD-B6BC0898A0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46379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FC7FF86-4685-D4F7-D2A6-F7B32CBC31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32B3A80-C696-7DAB-435E-72F8301E6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6144D-93FC-465C-BD67-DC6F4031BE5F}" type="datetimeFigureOut">
              <a:rPr lang="zh-CN" altLang="en-US" smtClean="0"/>
              <a:t>2025/1/1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7731E7F-AB2F-3739-A0AD-112AB52355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6C6D60F-F314-B40A-7C18-B6F49681F7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5D10B-722A-4F78-B4DD-B6BC0898A0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9678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DAEA96D-3AC0-261F-1618-0D21D06366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6144D-93FC-465C-BD67-DC6F4031BE5F}" type="datetimeFigureOut">
              <a:rPr lang="zh-CN" altLang="en-US" smtClean="0"/>
              <a:t>2025/1/1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CE1CA6C-5F68-AA3F-2892-D1F601CF77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627574D6-6163-AB3F-5643-CE553DA57C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5D10B-722A-4F78-B4DD-B6BC0898A0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2323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9820CE-06FD-6980-28EC-2CA7D45154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8977286-90B3-5D8A-EF0E-24DA6EA2068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90FB9D5-0751-1243-E35C-DE1F365AD7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BACFC81-E021-CD48-EADE-5DF25F9E28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6144D-93FC-465C-BD67-DC6F4031BE5F}" type="datetimeFigureOut">
              <a:rPr lang="zh-CN" altLang="en-US" smtClean="0"/>
              <a:t>2025/1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3749105-2D82-FBD7-AF82-42FCA8B31B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186DEBF-473A-F0B9-D232-D84277EBD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5D10B-722A-4F78-B4DD-B6BC0898A0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0939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03D527-D188-37E6-99E1-ED05C0BEB8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2765CF3-61CB-AF1A-BAF8-88415888A6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A9F563A-3599-D6C1-975E-8ECFEBDBC0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7992E0F-377D-7A1E-A0CB-5C52BC961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86144D-93FC-465C-BD67-DC6F4031BE5F}" type="datetimeFigureOut">
              <a:rPr lang="zh-CN" altLang="en-US" smtClean="0"/>
              <a:t>2025/1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81A445A-A2FE-1B51-20F4-2C67DDC8D8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370D2B2-D8BD-CE68-F443-358B85B8A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65D10B-722A-4F78-B4DD-B6BC0898A0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9922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E590A4E-A16F-4824-CB4E-4FDF6A9877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E6F5BD9-D10F-A695-0104-807AF2D1E8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FE50522-0960-BF51-CC04-C9976B097A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86144D-93FC-465C-BD67-DC6F4031BE5F}" type="datetimeFigureOut">
              <a:rPr lang="zh-CN" altLang="en-US" smtClean="0"/>
              <a:t>2025/1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FAD5E8-8968-9065-5447-329F350AFD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89DA331-AD4F-612C-67B3-111A136EEE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65D10B-722A-4F78-B4DD-B6BC0898A0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62173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1A8711A-5720-C9BB-4DFA-22ED99FB97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482" y="0"/>
            <a:ext cx="9311951" cy="68580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4728B2AD-A4E9-CEDC-9342-73238E211ED8}"/>
              </a:ext>
            </a:extLst>
          </p:cNvPr>
          <p:cNvSpPr txBox="1"/>
          <p:nvPr/>
        </p:nvSpPr>
        <p:spPr>
          <a:xfrm>
            <a:off x="9832258" y="2595716"/>
            <a:ext cx="2290916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sured and theoretical elevations with error corrected of cantilevers LL5~LL20 after pouring during the construction of the left-side bridge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60868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7A38A0E0-17E0-5A65-DF8D-07CDFE51F0A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066" y="0"/>
            <a:ext cx="9352487" cy="685800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DC16EF52-27E5-A679-4548-02FD67825A69}"/>
              </a:ext>
            </a:extLst>
          </p:cNvPr>
          <p:cNvSpPr txBox="1"/>
          <p:nvPr/>
        </p:nvSpPr>
        <p:spPr>
          <a:xfrm>
            <a:off x="9586452" y="2595716"/>
            <a:ext cx="2536722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sured and theoretical elevations with error corrected of cantilevers LL5~LL20 after tensioning prestressing steel during the construction of the left-side bridge.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7980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46</Words>
  <Application>Microsoft Office PowerPoint</Application>
  <PresentationFormat>宽屏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ia Al</dc:creator>
  <cp:lastModifiedBy>sia Al</cp:lastModifiedBy>
  <cp:revision>1</cp:revision>
  <dcterms:created xsi:type="dcterms:W3CDTF">2025-01-11T09:49:56Z</dcterms:created>
  <dcterms:modified xsi:type="dcterms:W3CDTF">2025-01-11T09:52:51Z</dcterms:modified>
</cp:coreProperties>
</file>